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23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nnar\Desktop\Science\May%202014%20submission\Resubmitt\Release%20in%20conditioned%20medi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nnar\Desktop\Science\May%202014%20submission\Resubmitt\Release%20in%20conditioned%20medi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nnar\Desktop\Science\May%202014%20submission\Resubmitt\Release%20in%20conditioned%20media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nnar\Desktop\Science\May%202014%20submission\Resubmitt\Release%20in%20conditioned%20media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nnar\Desktop\Science\May%202014%20submission\Resubmitt\Release%20in%20conditioned%20medi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NHSC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trendline>
            <c:trendlineType val="linear"/>
            <c:dispRSqr val="1"/>
            <c:dispEq val="0"/>
            <c:trendlineLbl>
              <c:layout/>
              <c:numFmt formatCode="General" sourceLinked="0"/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Summary time course'!$O$3:$O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12.5</c:v>
                  </c:pt>
                  <c:pt idx="6">
                    <c:v>17</c:v>
                  </c:pt>
                  <c:pt idx="7">
                    <c:v>48</c:v>
                  </c:pt>
                </c:numCache>
              </c:numRef>
            </c:plus>
            <c:minus>
              <c:numRef>
                <c:f>'Summary time course'!$O$3:$O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12.5</c:v>
                  </c:pt>
                  <c:pt idx="6">
                    <c:v>17</c:v>
                  </c:pt>
                  <c:pt idx="7">
                    <c:v>48</c:v>
                  </c:pt>
                </c:numCache>
              </c:numRef>
            </c:minus>
          </c:errBars>
          <c:xVal>
            <c:numRef>
              <c:f>'Summary time course'!$C$3:$C$10</c:f>
              <c:numCache>
                <c:formatCode>General</c:formatCode>
                <c:ptCount val="8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8</c:v>
                </c:pt>
                <c:pt idx="6">
                  <c:v>24</c:v>
                </c:pt>
                <c:pt idx="7">
                  <c:v>48</c:v>
                </c:pt>
              </c:numCache>
            </c:numRef>
          </c:xVal>
          <c:yVal>
            <c:numRef>
              <c:f>'Summary time course'!$H$3:$H$10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30</c:v>
                </c:pt>
                <c:pt idx="5">
                  <c:v>52</c:v>
                </c:pt>
                <c:pt idx="6">
                  <c:v>118</c:v>
                </c:pt>
                <c:pt idx="7">
                  <c:v>26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0907472"/>
        <c:axId val="190908032"/>
      </c:scatterChart>
      <c:valAx>
        <c:axId val="190907472"/>
        <c:scaling>
          <c:orientation val="minMax"/>
          <c:max val="5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190908032"/>
        <c:crosses val="autoZero"/>
        <c:crossBetween val="midCat"/>
        <c:majorUnit val="8"/>
      </c:valAx>
      <c:valAx>
        <c:axId val="190908032"/>
        <c:scaling>
          <c:orientation val="minMax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090747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Summary time course'!$F$2</c:f>
              <c:strCache>
                <c:ptCount val="1"/>
                <c:pt idx="0">
                  <c:v>T265</c:v>
                </c:pt>
              </c:strCache>
            </c:strRef>
          </c:tx>
          <c:spPr>
            <a:ln w="28575">
              <a:noFill/>
            </a:ln>
          </c:spPr>
          <c:trendline>
            <c:trendlineType val="linear"/>
            <c:dispRSqr val="1"/>
            <c:dispEq val="0"/>
            <c:trendlineLbl>
              <c:layout/>
              <c:numFmt formatCode="General" sourceLinked="0"/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Summary time course'!$M$3:$M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11.576688051856626</c:v>
                  </c:pt>
                  <c:pt idx="4">
                    <c:v>32.267057601368045</c:v>
                  </c:pt>
                  <c:pt idx="5">
                    <c:v>41.024359506477133</c:v>
                  </c:pt>
                  <c:pt idx="6">
                    <c:v>69.158230409209153</c:v>
                  </c:pt>
                  <c:pt idx="7">
                    <c:v>287.7296027378257</c:v>
                  </c:pt>
                </c:numCache>
              </c:numRef>
            </c:plus>
            <c:minus>
              <c:numRef>
                <c:f>'Summary time course'!$M$3:$M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11.576688051856626</c:v>
                  </c:pt>
                  <c:pt idx="4">
                    <c:v>32.267057601368045</c:v>
                  </c:pt>
                  <c:pt idx="5">
                    <c:v>41.024359506477133</c:v>
                  </c:pt>
                  <c:pt idx="6">
                    <c:v>69.158230409209153</c:v>
                  </c:pt>
                  <c:pt idx="7">
                    <c:v>287.7296027378257</c:v>
                  </c:pt>
                </c:numCache>
              </c:numRef>
            </c:minus>
          </c:errBars>
          <c:xVal>
            <c:numRef>
              <c:f>'Summary time course'!$C$3:$C$10</c:f>
              <c:numCache>
                <c:formatCode>General</c:formatCode>
                <c:ptCount val="8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8</c:v>
                </c:pt>
                <c:pt idx="6">
                  <c:v>24</c:v>
                </c:pt>
                <c:pt idx="7">
                  <c:v>48</c:v>
                </c:pt>
              </c:numCache>
            </c:numRef>
          </c:xVal>
          <c:yVal>
            <c:numRef>
              <c:f>'Summary time course'!$F$3:$F$10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39.521250000000002</c:v>
                </c:pt>
                <c:pt idx="4">
                  <c:v>126.58874999999998</c:v>
                </c:pt>
                <c:pt idx="5">
                  <c:v>271.73874999999936</c:v>
                </c:pt>
                <c:pt idx="6">
                  <c:v>557.06499999999949</c:v>
                </c:pt>
                <c:pt idx="7">
                  <c:v>1398.267499999999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0910832"/>
        <c:axId val="190911392"/>
      </c:scatterChart>
      <c:valAx>
        <c:axId val="190910832"/>
        <c:scaling>
          <c:orientation val="minMax"/>
          <c:max val="5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190911392"/>
        <c:crosses val="autoZero"/>
        <c:crossBetween val="midCat"/>
        <c:majorUnit val="8"/>
      </c:valAx>
      <c:valAx>
        <c:axId val="190911392"/>
        <c:scaling>
          <c:orientation val="minMax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091083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Summary time course'!$E$2</c:f>
              <c:strCache>
                <c:ptCount val="1"/>
                <c:pt idx="0">
                  <c:v>ST8814</c:v>
                </c:pt>
              </c:strCache>
            </c:strRef>
          </c:tx>
          <c:spPr>
            <a:ln w="28575">
              <a:noFill/>
            </a:ln>
          </c:spPr>
          <c:trendline>
            <c:trendlineType val="linear"/>
            <c:dispRSqr val="1"/>
            <c:dispEq val="0"/>
            <c:trendlineLbl>
              <c:layout/>
              <c:numFmt formatCode="General" sourceLinked="0"/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Summary time course'!$L$3:$L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19.591450675826266</c:v>
                  </c:pt>
                  <c:pt idx="4">
                    <c:v>11.653438244426715</c:v>
                  </c:pt>
                  <c:pt idx="5">
                    <c:v>26.528802586371736</c:v>
                  </c:pt>
                  <c:pt idx="6">
                    <c:v>66.113318171025838</c:v>
                  </c:pt>
                  <c:pt idx="7">
                    <c:v>146.46348147661226</c:v>
                  </c:pt>
                </c:numCache>
              </c:numRef>
            </c:plus>
            <c:minus>
              <c:numRef>
                <c:f>'Summary time course'!$L$3:$L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19.591450675826266</c:v>
                  </c:pt>
                  <c:pt idx="4">
                    <c:v>11.653438244426715</c:v>
                  </c:pt>
                  <c:pt idx="5">
                    <c:v>26.528802586371736</c:v>
                  </c:pt>
                  <c:pt idx="6">
                    <c:v>66.113318171025838</c:v>
                  </c:pt>
                  <c:pt idx="7">
                    <c:v>146.46348147661226</c:v>
                  </c:pt>
                </c:numCache>
              </c:numRef>
            </c:minus>
          </c:errBars>
          <c:xVal>
            <c:numRef>
              <c:f>'Summary time course'!$C$3:$C$10</c:f>
              <c:numCache>
                <c:formatCode>General</c:formatCode>
                <c:ptCount val="8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8</c:v>
                </c:pt>
                <c:pt idx="6">
                  <c:v>24</c:v>
                </c:pt>
                <c:pt idx="7">
                  <c:v>48</c:v>
                </c:pt>
              </c:numCache>
            </c:numRef>
          </c:xVal>
          <c:yVal>
            <c:numRef>
              <c:f>'Summary time course'!$E$3:$E$10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8.938749999999956</c:v>
                </c:pt>
                <c:pt idx="4">
                  <c:v>53.936250000000001</c:v>
                </c:pt>
                <c:pt idx="5">
                  <c:v>183.34499999999997</c:v>
                </c:pt>
                <c:pt idx="6">
                  <c:v>381.97874999999954</c:v>
                </c:pt>
                <c:pt idx="7">
                  <c:v>592.5187500000005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0913632"/>
        <c:axId val="44060352"/>
      </c:scatterChart>
      <c:valAx>
        <c:axId val="190913632"/>
        <c:scaling>
          <c:orientation val="minMax"/>
          <c:max val="5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44060352"/>
        <c:crosses val="autoZero"/>
        <c:crossBetween val="midCat"/>
        <c:majorUnit val="8"/>
      </c:valAx>
      <c:valAx>
        <c:axId val="44060352"/>
        <c:scaling>
          <c:orientation val="minMax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091363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Summary time course'!$G$2</c:f>
              <c:strCache>
                <c:ptCount val="1"/>
                <c:pt idx="0">
                  <c:v>S462</c:v>
                </c:pt>
              </c:strCache>
            </c:strRef>
          </c:tx>
          <c:spPr>
            <a:ln w="28575">
              <a:noFill/>
            </a:ln>
          </c:spPr>
          <c:trendline>
            <c:trendlineType val="linear"/>
            <c:dispRSqr val="1"/>
            <c:dispEq val="0"/>
            <c:trendlineLbl>
              <c:layout/>
              <c:numFmt formatCode="General" sourceLinked="0"/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Summary time course'!$N$3:$N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7.2473424727044682</c:v>
                  </c:pt>
                  <c:pt idx="7">
                    <c:v>41.801946999113113</c:v>
                  </c:pt>
                </c:numCache>
              </c:numRef>
            </c:plus>
            <c:minus>
              <c:numRef>
                <c:f>'Summary time course'!$N$3:$N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7.2473424727044682</c:v>
                  </c:pt>
                  <c:pt idx="7">
                    <c:v>41.801946999113113</c:v>
                  </c:pt>
                </c:numCache>
              </c:numRef>
            </c:minus>
          </c:errBars>
          <c:xVal>
            <c:numRef>
              <c:f>'Summary time course'!$C$3:$C$10</c:f>
              <c:numCache>
                <c:formatCode>General</c:formatCode>
                <c:ptCount val="8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8</c:v>
                </c:pt>
                <c:pt idx="6">
                  <c:v>24</c:v>
                </c:pt>
                <c:pt idx="7">
                  <c:v>48</c:v>
                </c:pt>
              </c:numCache>
            </c:numRef>
          </c:xVal>
          <c:yVal>
            <c:numRef>
              <c:f>'Summary time course'!$G$3:$G$10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50.488750000000003</c:v>
                </c:pt>
                <c:pt idx="7">
                  <c:v>140.2812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1695392"/>
        <c:axId val="201695952"/>
      </c:scatterChart>
      <c:valAx>
        <c:axId val="201695392"/>
        <c:scaling>
          <c:orientation val="minMax"/>
          <c:max val="5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201695952"/>
        <c:crosses val="autoZero"/>
        <c:crossBetween val="midCat"/>
        <c:majorUnit val="8"/>
      </c:valAx>
      <c:valAx>
        <c:axId val="201695952"/>
        <c:scaling>
          <c:orientation val="minMax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169539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Summary time course'!$D$2</c:f>
              <c:strCache>
                <c:ptCount val="1"/>
                <c:pt idx="0">
                  <c:v>STS26T</c:v>
                </c:pt>
              </c:strCache>
            </c:strRef>
          </c:tx>
          <c:spPr>
            <a:ln w="28575">
              <a:noFill/>
            </a:ln>
          </c:spPr>
          <c:trendline>
            <c:trendlineType val="linear"/>
            <c:dispRSqr val="1"/>
            <c:dispEq val="0"/>
            <c:trendlineLbl>
              <c:layout/>
              <c:numFmt formatCode="General" sourceLinked="0"/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Summary time course'!$K$3:$K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4.4421417038031148</c:v>
                  </c:pt>
                  <c:pt idx="2">
                    <c:v>19.386622105634217</c:v>
                  </c:pt>
                  <c:pt idx="3">
                    <c:v>34.461877820523156</c:v>
                  </c:pt>
                  <c:pt idx="4">
                    <c:v>33.100242823882546</c:v>
                  </c:pt>
                  <c:pt idx="5">
                    <c:v>121.11922074275931</c:v>
                  </c:pt>
                  <c:pt idx="6">
                    <c:v>244.63427469643472</c:v>
                  </c:pt>
                  <c:pt idx="7">
                    <c:v>727.67803946296783</c:v>
                  </c:pt>
                </c:numCache>
              </c:numRef>
            </c:plus>
            <c:minus>
              <c:numRef>
                <c:f>'Summary time course'!$K$3:$K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4.4421417038031148</c:v>
                  </c:pt>
                  <c:pt idx="2">
                    <c:v>19.386622105634217</c:v>
                  </c:pt>
                  <c:pt idx="3">
                    <c:v>34.461877820523156</c:v>
                  </c:pt>
                  <c:pt idx="4">
                    <c:v>33.100242823882546</c:v>
                  </c:pt>
                  <c:pt idx="5">
                    <c:v>121.11922074275931</c:v>
                  </c:pt>
                  <c:pt idx="6">
                    <c:v>244.63427469643472</c:v>
                  </c:pt>
                  <c:pt idx="7">
                    <c:v>727.67803946296783</c:v>
                  </c:pt>
                </c:numCache>
              </c:numRef>
            </c:minus>
          </c:errBars>
          <c:xVal>
            <c:numRef>
              <c:f>'Summary time course'!$C$3:$C$10</c:f>
              <c:numCache>
                <c:formatCode>General</c:formatCode>
                <c:ptCount val="8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8</c:v>
                </c:pt>
                <c:pt idx="6">
                  <c:v>24</c:v>
                </c:pt>
                <c:pt idx="7">
                  <c:v>48</c:v>
                </c:pt>
              </c:numCache>
            </c:numRef>
          </c:xVal>
          <c:yVal>
            <c:numRef>
              <c:f>'Summary time course'!$D$3:$D$10</c:f>
              <c:numCache>
                <c:formatCode>General</c:formatCode>
                <c:ptCount val="8"/>
                <c:pt idx="0">
                  <c:v>0</c:v>
                </c:pt>
                <c:pt idx="1">
                  <c:v>15.766250000000001</c:v>
                </c:pt>
                <c:pt idx="2">
                  <c:v>55.695000000000043</c:v>
                </c:pt>
                <c:pt idx="3">
                  <c:v>110.39375</c:v>
                </c:pt>
                <c:pt idx="4">
                  <c:v>241.13750000000002</c:v>
                </c:pt>
                <c:pt idx="5">
                  <c:v>616.625</c:v>
                </c:pt>
                <c:pt idx="6">
                  <c:v>1994.4262500000011</c:v>
                </c:pt>
                <c:pt idx="7">
                  <c:v>3493.6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1698192"/>
        <c:axId val="201698752"/>
      </c:scatterChart>
      <c:valAx>
        <c:axId val="201698192"/>
        <c:scaling>
          <c:orientation val="minMax"/>
          <c:max val="5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201698752"/>
        <c:crosses val="autoZero"/>
        <c:crossBetween val="midCat"/>
        <c:majorUnit val="8"/>
      </c:valAx>
      <c:valAx>
        <c:axId val="201698752"/>
        <c:scaling>
          <c:orientation val="minMax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169819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4D7E-3846-494E-AEAC-A13BFE0436B2}" type="datetimeFigureOut">
              <a:rPr lang="sv-SE" smtClean="0"/>
              <a:pPr/>
              <a:t>2014-10-26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CF728-2071-462D-B04A-2FB265FD4987}" type="slidenum">
              <a:rPr lang="sv-SE" smtClean="0"/>
              <a:pPr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4D7E-3846-494E-AEAC-A13BFE0436B2}" type="datetimeFigureOut">
              <a:rPr lang="sv-SE" smtClean="0"/>
              <a:pPr/>
              <a:t>2014-10-26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CF728-2071-462D-B04A-2FB265FD4987}" type="slidenum">
              <a:rPr lang="sv-SE" smtClean="0"/>
              <a:pPr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4D7E-3846-494E-AEAC-A13BFE0436B2}" type="datetimeFigureOut">
              <a:rPr lang="sv-SE" smtClean="0"/>
              <a:pPr/>
              <a:t>2014-10-26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CF728-2071-462D-B04A-2FB265FD4987}" type="slidenum">
              <a:rPr lang="sv-SE" smtClean="0"/>
              <a:pPr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4D7E-3846-494E-AEAC-A13BFE0436B2}" type="datetimeFigureOut">
              <a:rPr lang="sv-SE" smtClean="0"/>
              <a:pPr/>
              <a:t>2014-10-26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CF728-2071-462D-B04A-2FB265FD4987}" type="slidenum">
              <a:rPr lang="sv-SE" smtClean="0"/>
              <a:pPr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4D7E-3846-494E-AEAC-A13BFE0436B2}" type="datetimeFigureOut">
              <a:rPr lang="sv-SE" smtClean="0"/>
              <a:pPr/>
              <a:t>2014-10-26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CF728-2071-462D-B04A-2FB265FD4987}" type="slidenum">
              <a:rPr lang="sv-SE" smtClean="0"/>
              <a:pPr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4D7E-3846-494E-AEAC-A13BFE0436B2}" type="datetimeFigureOut">
              <a:rPr lang="sv-SE" smtClean="0"/>
              <a:pPr/>
              <a:t>2014-10-26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CF728-2071-462D-B04A-2FB265FD4987}" type="slidenum">
              <a:rPr lang="sv-SE" smtClean="0"/>
              <a:pPr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4D7E-3846-494E-AEAC-A13BFE0436B2}" type="datetimeFigureOut">
              <a:rPr lang="sv-SE" smtClean="0"/>
              <a:pPr/>
              <a:t>2014-10-26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CF728-2071-462D-B04A-2FB265FD4987}" type="slidenum">
              <a:rPr lang="sv-SE" smtClean="0"/>
              <a:pPr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4D7E-3846-494E-AEAC-A13BFE0436B2}" type="datetimeFigureOut">
              <a:rPr lang="sv-SE" smtClean="0"/>
              <a:pPr/>
              <a:t>2014-10-26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CF728-2071-462D-B04A-2FB265FD4987}" type="slidenum">
              <a:rPr lang="sv-SE" smtClean="0"/>
              <a:pPr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4D7E-3846-494E-AEAC-A13BFE0436B2}" type="datetimeFigureOut">
              <a:rPr lang="sv-SE" smtClean="0"/>
              <a:pPr/>
              <a:t>2014-10-26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CF728-2071-462D-B04A-2FB265FD4987}" type="slidenum">
              <a:rPr lang="sv-SE" smtClean="0"/>
              <a:pPr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4D7E-3846-494E-AEAC-A13BFE0436B2}" type="datetimeFigureOut">
              <a:rPr lang="sv-SE" smtClean="0"/>
              <a:pPr/>
              <a:t>2014-10-26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CF728-2071-462D-B04A-2FB265FD4987}" type="slidenum">
              <a:rPr lang="sv-SE" smtClean="0"/>
              <a:pPr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4D7E-3846-494E-AEAC-A13BFE0436B2}" type="datetimeFigureOut">
              <a:rPr lang="sv-SE" smtClean="0"/>
              <a:pPr/>
              <a:t>2014-10-26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CF728-2071-462D-B04A-2FB265FD4987}" type="slidenum">
              <a:rPr lang="sv-SE" smtClean="0"/>
              <a:pPr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1B4D7E-3846-494E-AEAC-A13BFE0436B2}" type="datetimeFigureOut">
              <a:rPr lang="sv-SE" smtClean="0"/>
              <a:pPr/>
              <a:t>2014-10-26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FCF728-2071-462D-B04A-2FB265FD4987}" type="slidenum">
              <a:rPr lang="sv-SE" smtClean="0"/>
              <a:pPr/>
              <a:t>‹#›</a:t>
            </a:fld>
            <a:endParaRPr lang="sv-S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381000" y="381000"/>
            <a:ext cx="838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 smtClean="0">
                <a:latin typeface="Arial" pitchFamily="34" charset="0"/>
                <a:cs typeface="Arial" pitchFamily="34" charset="0"/>
              </a:rPr>
              <a:t>Supplemental Figure </a:t>
            </a:r>
            <a:r>
              <a:rPr lang="sv-SE" b="1" dirty="0" smtClean="0">
                <a:latin typeface="Arial" pitchFamily="34" charset="0"/>
                <a:cs typeface="Arial" pitchFamily="34" charset="0"/>
              </a:rPr>
              <a:t>1:</a:t>
            </a:r>
            <a:r>
              <a:rPr lang="zh-TW" altLang="zh-TW" b="1" dirty="0"/>
              <a:t>Release of sAXL in MPNST cell lines (STS26T, ST8814, S462, and T265) and normal human Schwann cells (NHSC).</a:t>
            </a:r>
            <a:endParaRPr lang="sv-SE" b="1" dirty="0" smtClean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6" name="Chart 25"/>
          <p:cNvGraphicFramePr/>
          <p:nvPr>
            <p:extLst>
              <p:ext uri="{D42A27DB-BD31-4B8C-83A1-F6EECF244321}">
                <p14:modId xmlns:p14="http://schemas.microsoft.com/office/powerpoint/2010/main" val="2271668643"/>
              </p:ext>
            </p:extLst>
          </p:nvPr>
        </p:nvGraphicFramePr>
        <p:xfrm>
          <a:off x="5935506" y="1811217"/>
          <a:ext cx="2772396" cy="20606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7" name="Chart 26"/>
          <p:cNvGraphicFramePr/>
          <p:nvPr>
            <p:extLst>
              <p:ext uri="{D42A27DB-BD31-4B8C-83A1-F6EECF244321}">
                <p14:modId xmlns:p14="http://schemas.microsoft.com/office/powerpoint/2010/main" val="697391683"/>
              </p:ext>
            </p:extLst>
          </p:nvPr>
        </p:nvGraphicFramePr>
        <p:xfrm>
          <a:off x="3052687" y="3808827"/>
          <a:ext cx="2757270" cy="23352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8" name="Chart 27"/>
          <p:cNvGraphicFramePr/>
          <p:nvPr>
            <p:extLst>
              <p:ext uri="{D42A27DB-BD31-4B8C-83A1-F6EECF244321}">
                <p14:modId xmlns:p14="http://schemas.microsoft.com/office/powerpoint/2010/main" val="3499904294"/>
              </p:ext>
            </p:extLst>
          </p:nvPr>
        </p:nvGraphicFramePr>
        <p:xfrm>
          <a:off x="3097238" y="1825283"/>
          <a:ext cx="2712720" cy="20364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9" name="Chart 28"/>
          <p:cNvGraphicFramePr/>
          <p:nvPr>
            <p:extLst>
              <p:ext uri="{D42A27DB-BD31-4B8C-83A1-F6EECF244321}">
                <p14:modId xmlns:p14="http://schemas.microsoft.com/office/powerpoint/2010/main" val="159597080"/>
              </p:ext>
            </p:extLst>
          </p:nvPr>
        </p:nvGraphicFramePr>
        <p:xfrm>
          <a:off x="375432" y="3869642"/>
          <a:ext cx="2691325" cy="23025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0" name="Chart 29"/>
          <p:cNvGraphicFramePr/>
          <p:nvPr>
            <p:extLst>
              <p:ext uri="{D42A27DB-BD31-4B8C-83A1-F6EECF244321}">
                <p14:modId xmlns:p14="http://schemas.microsoft.com/office/powerpoint/2010/main" val="2877637372"/>
              </p:ext>
            </p:extLst>
          </p:nvPr>
        </p:nvGraphicFramePr>
        <p:xfrm>
          <a:off x="351692" y="1754945"/>
          <a:ext cx="2658794" cy="20116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41</Words>
  <Application>Microsoft Office PowerPoint</Application>
  <PresentationFormat>如螢幕大小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5" baseType="lpstr">
      <vt:lpstr>新細明體</vt:lpstr>
      <vt:lpstr>Arial</vt:lpstr>
      <vt:lpstr>Calibri</vt:lpstr>
      <vt:lpstr>Office Theme</vt:lpstr>
      <vt:lpstr>PowerPoint 簡報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unnar</dc:creator>
  <cp:lastModifiedBy>Lee Ming</cp:lastModifiedBy>
  <cp:revision>10</cp:revision>
  <dcterms:created xsi:type="dcterms:W3CDTF">2014-06-07T09:43:02Z</dcterms:created>
  <dcterms:modified xsi:type="dcterms:W3CDTF">2014-10-26T10:02:03Z</dcterms:modified>
</cp:coreProperties>
</file>